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792913" cy="99187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3200" cy="9918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4800" cy="49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8040" y="0"/>
            <a:ext cx="2944800" cy="49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굴림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59360" cy="3719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8960" y="4711680"/>
            <a:ext cx="5435640" cy="446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1920"/>
            <a:ext cx="2944800" cy="49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8040" y="9421920"/>
            <a:ext cx="2944800" cy="49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0427996-F2B3-42D0-883E-89FA61FDC908}" type="slidenum">
              <a:rPr b="0" lang="en-US" sz="12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59360" cy="3719520"/>
          </a:xfrm>
          <a:prstGeom prst="rect">
            <a:avLst/>
          </a:prstGeom>
          <a:ln w="0">
            <a:noFill/>
          </a:ln>
        </p:spPr>
      </p:sp>
      <p:sp>
        <p:nvSpPr>
          <p:cNvPr id="90" name="PlaceHolder 2"/>
          <p:cNvSpPr>
            <a:spLocks noGrp="1"/>
          </p:cNvSpPr>
          <p:nvPr>
            <p:ph type="body"/>
          </p:nvPr>
        </p:nvSpPr>
        <p:spPr>
          <a:xfrm>
            <a:off x="678960" y="4711680"/>
            <a:ext cx="5435640" cy="4462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Slide Number Placeholder 3"/>
          <p:cNvSpPr/>
          <p:nvPr/>
        </p:nvSpPr>
        <p:spPr>
          <a:xfrm>
            <a:off x="3848040" y="9421920"/>
            <a:ext cx="2944800" cy="49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6623D6B-60F1-4EC0-8E02-03C49C0BE29A}" type="slidenum">
              <a:rPr b="0" lang="en-US" sz="1200" spc="-1" strike="noStrike">
                <a:solidFill>
                  <a:srgbClr val="000000"/>
                </a:solidFill>
                <a:latin typeface="굴림"/>
                <a:ea typeface="굴림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F343DC-BD91-4CA4-AEAC-C2CDCCE9FDF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07AC2B-B689-47CB-BBC0-7FEFAF00C9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ABBBFE-1310-4ACD-AA24-264A4B1029E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0E543C-8877-4911-B6BB-4ACD5697EB0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6DABFD-052A-48E7-8A41-46AD64A31A4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D97970-82AA-40AA-AA69-0B74554012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0CED3F-DD40-4A77-94C4-91DBDF96DD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66F284-46A4-4DCE-A07D-CB22F14374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CDAE77-2F53-481D-A960-DA676E165F1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A8E9F2-C3D2-490E-8529-1EAC9678EF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306EEB-EBAE-44A8-97AC-795A3366F2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85D171-ADCD-4C2A-AEBE-D383E4925C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71EA0EB-CD64-43C8-BEBD-39DF494748DE}" type="slidenum">
              <a:rPr b="0" lang="en-US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3"/>
          <p:cNvSpPr/>
          <p:nvPr/>
        </p:nvSpPr>
        <p:spPr>
          <a:xfrm>
            <a:off x="4014720" y="606600"/>
            <a:ext cx="1555920" cy="4646520"/>
          </a:xfrm>
          <a:prstGeom prst="rect">
            <a:avLst/>
          </a:prstGeom>
          <a:solidFill>
            <a:srgbClr val="ffff8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9" name="Text Box 778"/>
          <p:cNvSpPr/>
          <p:nvPr/>
        </p:nvSpPr>
        <p:spPr>
          <a:xfrm>
            <a:off x="7220520" y="0"/>
            <a:ext cx="1917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cc"/>
                </a:solidFill>
                <a:latin typeface="Arial Narrow"/>
                <a:ea typeface="Vrinda"/>
              </a:rPr>
              <a:t>Figure S7. Yun </a:t>
            </a:r>
            <a:r>
              <a:rPr b="0" i="1" lang="en-US" sz="1400" spc="-1" strike="noStrike">
                <a:solidFill>
                  <a:srgbClr val="0000cc"/>
                </a:solidFill>
                <a:latin typeface="Arial Narrow"/>
                <a:ea typeface="Vrinda"/>
              </a:rPr>
              <a:t>et al</a:t>
            </a:r>
            <a:r>
              <a:rPr b="0" lang="en-US" sz="1400" spc="-1" strike="noStrike">
                <a:solidFill>
                  <a:srgbClr val="0000cc"/>
                </a:solidFill>
                <a:latin typeface="Arial Narrow"/>
                <a:ea typeface="Vrinda"/>
              </a:rPr>
              <a:t>., 2014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0" name="Rectangle 1"/>
          <p:cNvSpPr/>
          <p:nvPr/>
        </p:nvSpPr>
        <p:spPr>
          <a:xfrm>
            <a:off x="569880" y="5427720"/>
            <a:ext cx="8045640" cy="1373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 baseline="30000">
                <a:solidFill>
                  <a:srgbClr val="000000"/>
                </a:solidFill>
                <a:latin typeface="Arial Narrow"/>
              </a:rPr>
              <a:t>a</a:t>
            </a:r>
            <a:r>
              <a:rPr b="0" i="1" lang="en-US" sz="900" spc="-1" strike="noStrike" baseline="30000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</a:rPr>
              <a:t>One hundred thirty five full-length genomic sequences are available in GenBank: AB196923, AB196924, AB196925, AB196926, AB241118, AB241119, AB551990, AB551991, AB551992, AB594829, AB698906, AB698907, AB698908, AB698909, AB830335, AB853904, AF069076, AF075723, AF098735, AF098736, AF098737, AF217620, AF221499, AF221500, AF254452, 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 Narrow"/>
              </a:rPr>
              <a:t>AF254453, AY303791, AY303792, AY303793, AY303794, AY303795, AY303796, AY303797, AY303798, AY316157, AY508812, AY508813, AY585242, AY585243, AY849939, EF107523, EF543861, EF623987, EF623988, EU429297, EU693899, FJ185036, FJ185037, FJ495189, GQ199609, GQ902058, GQ902059, GQ902060, GQ902061, GQ902062, GQ902063, 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 Narrow"/>
              </a:rPr>
              <a:t>GQ918133, GU187972, GU205163, GU556217, HM228921, HM366552, HQ893545, JF499788, JF499789, JF499790, JF706267, JF706268, JF706269, JF706270, JF706271, JF706272, 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 Narrow"/>
              </a:rPr>
              <a:t>JF706273, JF706274, JF706275, JF706276, JF706277, JF706278, JF706279, JF706280, JF706281, JF706282, JF706283, JF706284, JF706285, JF706286, JN381830, JN381831, 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 Narrow"/>
              </a:rPr>
              <a:t>JN381832, JN381833, JN381834, JN381835, JN381836, JN381837, JN381838, JN381839, JN381840, JN381841, JN381842, JN381843, JN381844, JN381845, JN381846, JN381847, 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 Narrow"/>
              </a:rPr>
              <a:t>JN381848, JN381849, JN381850, JN381851, JN381852, JN381853, JN381854, JN381855, JN381856, JN381857, JN381858, JN381859, JN381860, JN381861, JN381862, JN381863, 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 Narrow"/>
              </a:rPr>
              <a:t>JN381864, JN381865, JN381866, JN381867, JN381868, JN381869, JN381870, JN381871, JN381872, JQ031753, JX072965, KC196115, L78128, NC_001437, U47032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1" name="TextBox 7"/>
          <p:cNvSpPr/>
          <p:nvPr/>
        </p:nvSpPr>
        <p:spPr>
          <a:xfrm>
            <a:off x="4440960" y="5205240"/>
            <a:ext cx="70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f0ea00"/>
                </a:solidFill>
                <a:latin typeface="Arial Narrow"/>
              </a:rPr>
              <a:t>ij </a:t>
            </a:r>
            <a:r>
              <a:rPr b="1" lang="en-US" sz="1200" spc="-1" strike="noStrike">
                <a:solidFill>
                  <a:srgbClr val="f0ea00"/>
                </a:solidFill>
                <a:latin typeface="Arial Narrow"/>
              </a:rPr>
              <a:t>hairpin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2" name="Straight Connector 16"/>
          <p:cNvSpPr/>
          <p:nvPr/>
        </p:nvSpPr>
        <p:spPr>
          <a:xfrm>
            <a:off x="671400" y="5254560"/>
            <a:ext cx="770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grpSp>
        <p:nvGrpSpPr>
          <p:cNvPr id="53" name="Group 24"/>
          <p:cNvGrpSpPr/>
          <p:nvPr/>
        </p:nvGrpSpPr>
        <p:grpSpPr>
          <a:xfrm>
            <a:off x="671400" y="309600"/>
            <a:ext cx="7704360" cy="512640"/>
            <a:chOff x="671400" y="309600"/>
            <a:chExt cx="7704360" cy="512640"/>
          </a:xfrm>
        </p:grpSpPr>
        <p:sp>
          <p:nvSpPr>
            <p:cNvPr id="54" name="Straight Connector 14"/>
            <p:cNvSpPr/>
            <p:nvPr/>
          </p:nvSpPr>
          <p:spPr>
            <a:xfrm>
              <a:off x="671400" y="822240"/>
              <a:ext cx="77043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5" name="Straight Connector 15"/>
            <p:cNvSpPr/>
            <p:nvPr/>
          </p:nvSpPr>
          <p:spPr>
            <a:xfrm>
              <a:off x="671400" y="606240"/>
              <a:ext cx="77043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grpSp>
          <p:nvGrpSpPr>
            <p:cNvPr id="56" name="Group 5"/>
            <p:cNvGrpSpPr/>
            <p:nvPr/>
          </p:nvGrpSpPr>
          <p:grpSpPr>
            <a:xfrm>
              <a:off x="3337200" y="309600"/>
              <a:ext cx="4488840" cy="259560"/>
              <a:chOff x="3337200" y="309600"/>
              <a:chExt cx="4488840" cy="259560"/>
            </a:xfrm>
          </p:grpSpPr>
          <p:sp>
            <p:nvSpPr>
              <p:cNvPr id="57" name="TextBox 26"/>
              <p:cNvSpPr/>
              <p:nvPr/>
            </p:nvSpPr>
            <p:spPr>
              <a:xfrm>
                <a:off x="4370760" y="309600"/>
                <a:ext cx="354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ff0000"/>
                    </a:solidFill>
                    <a:latin typeface="Arial Narrow"/>
                  </a:rPr>
                  <a:t>244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8" name="TextBox 27"/>
              <p:cNvSpPr/>
              <p:nvPr/>
            </p:nvSpPr>
            <p:spPr>
              <a:xfrm>
                <a:off x="3337200" y="309600"/>
                <a:ext cx="354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234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9" name="TextBox 28"/>
              <p:cNvSpPr/>
              <p:nvPr/>
            </p:nvSpPr>
            <p:spPr>
              <a:xfrm>
                <a:off x="5404320" y="309600"/>
                <a:ext cx="354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254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60" name="TextBox 29"/>
              <p:cNvSpPr/>
              <p:nvPr/>
            </p:nvSpPr>
            <p:spPr>
              <a:xfrm>
                <a:off x="6437880" y="309600"/>
                <a:ext cx="354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264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61" name="TextBox 30"/>
              <p:cNvSpPr/>
              <p:nvPr/>
            </p:nvSpPr>
            <p:spPr>
              <a:xfrm>
                <a:off x="7471440" y="309600"/>
                <a:ext cx="354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274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62" name="Oval 4"/>
              <p:cNvSpPr/>
              <p:nvPr/>
            </p:nvSpPr>
            <p:spPr>
              <a:xfrm>
                <a:off x="4451040" y="511920"/>
                <a:ext cx="56880" cy="57240"/>
              </a:xfrm>
              <a:prstGeom prst="ellipse">
                <a:avLst/>
              </a:prstGeom>
              <a:solidFill>
                <a:srgbClr val="ff0000"/>
              </a:solidFill>
              <a:ln w="32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63" name="Oval 18"/>
              <p:cNvSpPr/>
              <p:nvPr/>
            </p:nvSpPr>
            <p:spPr>
              <a:xfrm>
                <a:off x="3417480" y="511920"/>
                <a:ext cx="56880" cy="57240"/>
              </a:xfrm>
              <a:prstGeom prst="ellipse">
                <a:avLst/>
              </a:prstGeom>
              <a:solidFill>
                <a:srgbClr val="000000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64" name="Oval 19"/>
              <p:cNvSpPr/>
              <p:nvPr/>
            </p:nvSpPr>
            <p:spPr>
              <a:xfrm>
                <a:off x="5484600" y="511920"/>
                <a:ext cx="56880" cy="57240"/>
              </a:xfrm>
              <a:prstGeom prst="ellipse">
                <a:avLst/>
              </a:prstGeom>
              <a:solidFill>
                <a:srgbClr val="000000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65" name="Oval 20"/>
              <p:cNvSpPr/>
              <p:nvPr/>
            </p:nvSpPr>
            <p:spPr>
              <a:xfrm>
                <a:off x="6518520" y="511920"/>
                <a:ext cx="56880" cy="57240"/>
              </a:xfrm>
              <a:prstGeom prst="ellipse">
                <a:avLst/>
              </a:prstGeom>
              <a:solidFill>
                <a:srgbClr val="000000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66" name="Oval 21"/>
              <p:cNvSpPr/>
              <p:nvPr/>
            </p:nvSpPr>
            <p:spPr>
              <a:xfrm>
                <a:off x="7550280" y="511920"/>
                <a:ext cx="58680" cy="57240"/>
              </a:xfrm>
              <a:prstGeom prst="ellipse">
                <a:avLst/>
              </a:prstGeom>
              <a:solidFill>
                <a:srgbClr val="000000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</p:grpSp>
      <p:graphicFrame>
        <p:nvGraphicFramePr>
          <p:cNvPr id="67" name=""/>
          <p:cNvGraphicFramePr/>
          <p:nvPr/>
        </p:nvGraphicFramePr>
        <p:xfrm>
          <a:off x="765000" y="631800"/>
          <a:ext cx="7848720" cy="4584600"/>
        </p:xfrm>
        <a:graphic>
          <a:graphicData uri="http://schemas.openxmlformats.org/drawingml/2006/table">
            <a:tbl>
              <a:tblPr/>
              <a:tblGrid>
                <a:gridCol w="2016360"/>
                <a:gridCol w="5832360"/>
              </a:tblGrid>
              <a:tr h="174240"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Majority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Lucida Console"/>
                        </a:rPr>
                        <a:t>PSSTAWRNRELLMEFE</a:t>
                      </a:r>
                      <a:r>
                        <a:rPr b="0" lang="en-US" sz="1100" spc="-1" strike="noStrike">
                          <a:solidFill>
                            <a:srgbClr val="ff0000"/>
                          </a:solidFill>
                          <a:latin typeface="Lucida Console"/>
                        </a:rPr>
                        <a:t>E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Lucida Console"/>
                        </a:rPr>
                        <a:t>AHATKQSVVALGSQEGGLHQALAGAIVVEYSSSVKL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52560"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4840"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35 JEV strains</a:t>
                      </a:r>
                      <a:r>
                        <a:rPr b="0" i="1" lang="en-US" sz="1300" spc="-1" strike="noStrike" baseline="20000">
                          <a:solidFill>
                            <a:srgbClr val="000000"/>
                          </a:solidFill>
                          <a:latin typeface="Arial Narrow"/>
                        </a:rPr>
                        <a:t>a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Lucida Console"/>
                        </a:rPr>
                        <a:t>......................................................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240"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cc0000"/>
                          </a:solidFill>
                          <a:latin typeface="Arial Narrow"/>
                        </a:rPr>
                        <a:t>SA</a:t>
                      </a:r>
                      <a:r>
                        <a:rPr b="1" lang="en-US" sz="1100" spc="-1" strike="noStrike" baseline="-15000">
                          <a:solidFill>
                            <a:srgbClr val="cc0000"/>
                          </a:solidFill>
                          <a:latin typeface="Arial Narrow"/>
                        </a:rPr>
                        <a:t>14</a:t>
                      </a:r>
                      <a:r>
                        <a:rPr b="0" lang="en-US" sz="1100" spc="-1" strike="noStrike">
                          <a:solidFill>
                            <a:srgbClr val="cc0000"/>
                          </a:solidFill>
                          <a:latin typeface="Arial Narrow"/>
                        </a:rPr>
                        <a:t> (U14163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cc0000"/>
                          </a:solidFill>
                          <a:latin typeface="Lucida Console"/>
                        </a:rPr>
                        <a:t>......................................................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240"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cc0000"/>
                          </a:solidFill>
                          <a:latin typeface="Arial Narrow"/>
                        </a:rPr>
                        <a:t>SA</a:t>
                      </a:r>
                      <a:r>
                        <a:rPr b="1" lang="en-US" sz="1100" spc="-1" strike="noStrike" baseline="-15000">
                          <a:solidFill>
                            <a:srgbClr val="cc0000"/>
                          </a:solidFill>
                          <a:latin typeface="Arial Narrow"/>
                        </a:rPr>
                        <a:t>14</a:t>
                      </a:r>
                      <a:r>
                        <a:rPr b="0" lang="en-US" sz="1100" spc="-1" strike="noStrike">
                          <a:solidFill>
                            <a:srgbClr val="cc0000"/>
                          </a:solidFill>
                          <a:latin typeface="Arial Narrow"/>
                        </a:rPr>
                        <a:t> (D90194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cc0000"/>
                          </a:solidFill>
                          <a:latin typeface="Lucida Console"/>
                        </a:rPr>
                        <a:t>................G.....................................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240"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cc0000"/>
                          </a:solidFill>
                          <a:latin typeface="Arial Narrow"/>
                        </a:rPr>
                        <a:t>SA</a:t>
                      </a:r>
                      <a:r>
                        <a:rPr b="1" lang="en-US" sz="1100" spc="-1" strike="noStrike" baseline="-15000">
                          <a:solidFill>
                            <a:srgbClr val="cc0000"/>
                          </a:solidFill>
                          <a:latin typeface="Arial Narrow"/>
                        </a:rPr>
                        <a:t>14</a:t>
                      </a:r>
                      <a:r>
                        <a:rPr b="0" lang="en-US" sz="1100" spc="-1" strike="noStrike">
                          <a:solidFill>
                            <a:srgbClr val="cc0000"/>
                          </a:solidFill>
                          <a:latin typeface="Arial Narrow"/>
                        </a:rPr>
                        <a:t> (M55506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cc0000"/>
                          </a:solidFill>
                          <a:latin typeface="Lucida Console"/>
                        </a:rPr>
                        <a:t>................G.....................................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240"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e28700"/>
                          </a:solidFill>
                          <a:latin typeface="Arial Narrow"/>
                        </a:rPr>
                        <a:t>SA</a:t>
                      </a:r>
                      <a:r>
                        <a:rPr b="1" lang="en-US" sz="1100" spc="-1" strike="noStrike" baseline="-15000">
                          <a:solidFill>
                            <a:srgbClr val="e28700"/>
                          </a:solidFill>
                          <a:latin typeface="Arial Narrow"/>
                        </a:rPr>
                        <a:t>14</a:t>
                      </a:r>
                      <a:r>
                        <a:rPr b="1" lang="en-US" sz="1100" spc="-1" strike="noStrike">
                          <a:solidFill>
                            <a:srgbClr val="e28700"/>
                          </a:solidFill>
                          <a:latin typeface="Arial Narrow"/>
                        </a:rPr>
                        <a:t>-2-8</a:t>
                      </a:r>
                      <a:r>
                        <a:rPr b="0" lang="en-US" sz="1100" spc="-1" strike="noStrike">
                          <a:solidFill>
                            <a:srgbClr val="e28700"/>
                          </a:solidFill>
                          <a:latin typeface="Arial Narrow"/>
                        </a:rPr>
                        <a:t> (U15763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e28700"/>
                          </a:solidFill>
                          <a:latin typeface="Lucida Console"/>
                        </a:rPr>
                        <a:t>................G.....................................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240"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cc"/>
                          </a:solidFill>
                          <a:latin typeface="Arial Narrow"/>
                        </a:rPr>
                        <a:t>SA</a:t>
                      </a:r>
                      <a:r>
                        <a:rPr b="1" lang="en-US" sz="1100" spc="-1" strike="noStrike" baseline="-15000">
                          <a:solidFill>
                            <a:srgbClr val="0000cc"/>
                          </a:solidFill>
                          <a:latin typeface="Arial Narrow"/>
                        </a:rPr>
                        <a:t>14</a:t>
                      </a:r>
                      <a:r>
                        <a:rPr b="1" lang="en-US" sz="1100" spc="-1" strike="noStrike">
                          <a:solidFill>
                            <a:srgbClr val="0000cc"/>
                          </a:solidFill>
                          <a:latin typeface="Arial Narrow"/>
                        </a:rPr>
                        <a:t>-12-1-7</a:t>
                      </a:r>
                      <a:r>
                        <a:rPr b="0" lang="en-US" sz="1100" spc="-1" strike="noStrike">
                          <a:solidFill>
                            <a:srgbClr val="0000cc"/>
                          </a:solidFill>
                          <a:latin typeface="Arial Narrow"/>
                        </a:rPr>
                        <a:t> (AF416457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cc"/>
                          </a:solidFill>
                          <a:latin typeface="Lucida Console"/>
                        </a:rPr>
                        <a:t>................G...................H.................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240"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9900"/>
                          </a:solidFill>
                          <a:latin typeface="Arial Narrow"/>
                        </a:rPr>
                        <a:t>SA</a:t>
                      </a:r>
                      <a:r>
                        <a:rPr b="1" lang="en-US" sz="1100" spc="-1" strike="noStrike" baseline="-15000">
                          <a:solidFill>
                            <a:srgbClr val="009900"/>
                          </a:solidFill>
                          <a:latin typeface="Arial Narrow"/>
                        </a:rPr>
                        <a:t>14</a:t>
                      </a:r>
                      <a:r>
                        <a:rPr b="1" lang="en-US" sz="1100" spc="-1" strike="noStrike">
                          <a:solidFill>
                            <a:srgbClr val="009900"/>
                          </a:solidFill>
                          <a:latin typeface="Arial Narrow"/>
                        </a:rPr>
                        <a:t>-14-2</a:t>
                      </a:r>
                      <a:r>
                        <a:rPr b="0" lang="en-US" sz="1100" spc="-1" strike="noStrike">
                          <a:solidFill>
                            <a:srgbClr val="009900"/>
                          </a:solidFill>
                          <a:latin typeface="Arial Narrow"/>
                        </a:rPr>
                        <a:t> (JN604986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9900"/>
                          </a:solidFill>
                          <a:latin typeface="Lucida Console"/>
                        </a:rPr>
                        <a:t>................G...................H..............M..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240"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9900"/>
                          </a:solidFill>
                          <a:latin typeface="Arial Narrow"/>
                        </a:rPr>
                        <a:t>SA</a:t>
                      </a:r>
                      <a:r>
                        <a:rPr b="1" lang="en-US" sz="1100" spc="-1" strike="noStrike" baseline="-15000">
                          <a:solidFill>
                            <a:srgbClr val="009900"/>
                          </a:solidFill>
                          <a:latin typeface="Arial Narrow"/>
                        </a:rPr>
                        <a:t>14</a:t>
                      </a:r>
                      <a:r>
                        <a:rPr b="1" lang="en-US" sz="1100" spc="-1" strike="noStrike">
                          <a:solidFill>
                            <a:srgbClr val="009900"/>
                          </a:solidFill>
                          <a:latin typeface="Arial Narrow"/>
                        </a:rPr>
                        <a:t>-14-2</a:t>
                      </a:r>
                      <a:r>
                        <a:rPr b="0" lang="en-US" sz="1100" spc="-1" strike="noStrike">
                          <a:solidFill>
                            <a:srgbClr val="009900"/>
                          </a:solidFill>
                          <a:latin typeface="Arial Narrow"/>
                        </a:rPr>
                        <a:t> (D90195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9900"/>
                          </a:solidFill>
                          <a:latin typeface="Lucida Console"/>
                        </a:rPr>
                        <a:t>................G...................H..............M..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240"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9900"/>
                          </a:solidFill>
                          <a:latin typeface="Arial Narrow"/>
                        </a:rPr>
                        <a:t>SA</a:t>
                      </a:r>
                      <a:r>
                        <a:rPr b="1" lang="en-US" sz="1100" spc="-1" strike="noStrike" baseline="-15000">
                          <a:solidFill>
                            <a:srgbClr val="009900"/>
                          </a:solidFill>
                          <a:latin typeface="Arial Narrow"/>
                        </a:rPr>
                        <a:t>14</a:t>
                      </a:r>
                      <a:r>
                        <a:rPr b="1" lang="en-US" sz="1100" spc="-1" strike="noStrike">
                          <a:solidFill>
                            <a:srgbClr val="009900"/>
                          </a:solidFill>
                          <a:latin typeface="Arial Narrow"/>
                        </a:rPr>
                        <a:t>-14-2</a:t>
                      </a:r>
                      <a:r>
                        <a:rPr b="0" lang="en-US" sz="1100" spc="-1" strike="noStrike">
                          <a:solidFill>
                            <a:srgbClr val="009900"/>
                          </a:solidFill>
                          <a:latin typeface="Arial Narrow"/>
                        </a:rPr>
                        <a:t> (AF315119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9900"/>
                          </a:solidFill>
                          <a:latin typeface="Lucida Console"/>
                        </a:rPr>
                        <a:t>................G...................H..............M..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240"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9900"/>
                          </a:solidFill>
                          <a:latin typeface="Arial Narrow"/>
                        </a:rPr>
                        <a:t>SA</a:t>
                      </a:r>
                      <a:r>
                        <a:rPr b="1" lang="en-US" sz="1100" spc="-1" strike="noStrike" baseline="-15000">
                          <a:solidFill>
                            <a:srgbClr val="009900"/>
                          </a:solidFill>
                          <a:latin typeface="Arial Narrow"/>
                        </a:rPr>
                        <a:t>14</a:t>
                      </a:r>
                      <a:r>
                        <a:rPr b="1" lang="en-US" sz="1100" spc="-1" strike="noStrike">
                          <a:solidFill>
                            <a:srgbClr val="009900"/>
                          </a:solidFill>
                          <a:latin typeface="Arial Narrow"/>
                        </a:rPr>
                        <a:t>-14-2</a:t>
                      </a:r>
                      <a:r>
                        <a:rPr b="0" lang="en-US" sz="1100" spc="-1" strike="noStrike">
                          <a:solidFill>
                            <a:srgbClr val="009900"/>
                          </a:solidFill>
                          <a:latin typeface="Arial Narrow"/>
                        </a:rPr>
                        <a:t> (KC517497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9900"/>
                          </a:solidFill>
                          <a:latin typeface="Lucida Console"/>
                        </a:rPr>
                        <a:t>................G.....................................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4240"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w/GD/01/2009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(KF297915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Lucida Console"/>
                        </a:rPr>
                        <a:t>................G..................................M..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4240"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K94P05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(AF045551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Lucida Console"/>
                        </a:rPr>
                        <a:t>................Q.....................................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4240"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GZ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(KC915016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Lucida Console"/>
                        </a:rPr>
                        <a:t>....T.................................................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4240"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DH107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(JN381873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Lucida Console"/>
                        </a:rPr>
                        <a:t>..........F...........................................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4240"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Vellore P20778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(AF080251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Lucida Console"/>
                        </a:rPr>
                        <a:t>.................................S....................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4240"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IND-WB-JE1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(JX050179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Lucida Console"/>
                        </a:rPr>
                        <a:t>.................................S....................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4240"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Eq/India/H225/2009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(JX131374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Lucida Console"/>
                        </a:rPr>
                        <a:t>.................................S....................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4240"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XZ0934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(JF915894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Lucida Console"/>
                        </a:rPr>
                        <a:t>....N.....I......................A....................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4240"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Muar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(HM596272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Lucida Console"/>
                        </a:rPr>
                        <a:t>....N.....I.L....................A....................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4240"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XJ69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(EU880214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Lucida Console"/>
                        </a:rPr>
                        <a:t>..............................R.......................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4240"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4940-4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(EF623989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Lucida Console"/>
                        </a:rPr>
                        <a:t>....................................H.................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4240"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Nakayama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(EF571853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Lucida Console"/>
                        </a:rPr>
                        <a:t>................................................N.....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4240"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GD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(JN711458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Lucida Console"/>
                        </a:rPr>
                        <a:t>................................................N.....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4240"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HN2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(JN711459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Lucida Console"/>
                        </a:rPr>
                        <a:t>................................................N.....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4240"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w/Mie/51/2006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(AB698905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Lucida Console"/>
                        </a:rPr>
                        <a:t>.....................................................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pSp>
        <p:nvGrpSpPr>
          <p:cNvPr id="68" name="Group 1"/>
          <p:cNvGrpSpPr/>
          <p:nvPr/>
        </p:nvGrpSpPr>
        <p:grpSpPr>
          <a:xfrm>
            <a:off x="706320" y="871560"/>
            <a:ext cx="0" cy="4330800"/>
            <a:chOff x="706320" y="871560"/>
            <a:chExt cx="0" cy="4330800"/>
          </a:xfrm>
        </p:grpSpPr>
        <p:sp>
          <p:nvSpPr>
            <p:cNvPr id="69" name="Straight Connector 17"/>
            <p:cNvSpPr/>
            <p:nvPr/>
          </p:nvSpPr>
          <p:spPr>
            <a:xfrm>
              <a:off x="706320" y="871560"/>
              <a:ext cx="0" cy="14436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0" name="Straight Connector 26"/>
            <p:cNvSpPr/>
            <p:nvPr/>
          </p:nvSpPr>
          <p:spPr>
            <a:xfrm>
              <a:off x="706320" y="5058000"/>
              <a:ext cx="0" cy="14436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1" name="Straight Connector 35"/>
            <p:cNvSpPr/>
            <p:nvPr/>
          </p:nvSpPr>
          <p:spPr>
            <a:xfrm>
              <a:off x="706320" y="2616120"/>
              <a:ext cx="0" cy="14436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2" name="Straight Connector 36"/>
            <p:cNvSpPr/>
            <p:nvPr/>
          </p:nvSpPr>
          <p:spPr>
            <a:xfrm>
              <a:off x="706320" y="2790720"/>
              <a:ext cx="0" cy="14256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3" name="Straight Connector 37"/>
            <p:cNvSpPr/>
            <p:nvPr/>
          </p:nvSpPr>
          <p:spPr>
            <a:xfrm>
              <a:off x="706320" y="2965680"/>
              <a:ext cx="0" cy="14256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4" name="Straight Connector 38"/>
            <p:cNvSpPr/>
            <p:nvPr/>
          </p:nvSpPr>
          <p:spPr>
            <a:xfrm>
              <a:off x="706320" y="3140280"/>
              <a:ext cx="0" cy="14256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5" name="Straight Connector 39"/>
            <p:cNvSpPr/>
            <p:nvPr/>
          </p:nvSpPr>
          <p:spPr>
            <a:xfrm>
              <a:off x="706320" y="3313080"/>
              <a:ext cx="0" cy="14436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6" name="Straight Connector 40"/>
            <p:cNvSpPr/>
            <p:nvPr/>
          </p:nvSpPr>
          <p:spPr>
            <a:xfrm>
              <a:off x="706320" y="3487680"/>
              <a:ext cx="0" cy="14436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7" name="Straight Connector 41"/>
            <p:cNvSpPr/>
            <p:nvPr/>
          </p:nvSpPr>
          <p:spPr>
            <a:xfrm>
              <a:off x="706320" y="3662640"/>
              <a:ext cx="0" cy="14436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8" name="Straight Connector 42"/>
            <p:cNvSpPr/>
            <p:nvPr/>
          </p:nvSpPr>
          <p:spPr>
            <a:xfrm>
              <a:off x="706320" y="3837240"/>
              <a:ext cx="0" cy="14436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9" name="Straight Connector 43"/>
            <p:cNvSpPr/>
            <p:nvPr/>
          </p:nvSpPr>
          <p:spPr>
            <a:xfrm>
              <a:off x="706320" y="4011840"/>
              <a:ext cx="0" cy="14436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0" name="Straight Connector 44"/>
            <p:cNvSpPr/>
            <p:nvPr/>
          </p:nvSpPr>
          <p:spPr>
            <a:xfrm>
              <a:off x="706320" y="4186440"/>
              <a:ext cx="0" cy="14436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1" name="Straight Connector 45"/>
            <p:cNvSpPr/>
            <p:nvPr/>
          </p:nvSpPr>
          <p:spPr>
            <a:xfrm>
              <a:off x="706320" y="4361040"/>
              <a:ext cx="0" cy="14256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2" name="Straight Connector 46"/>
            <p:cNvSpPr/>
            <p:nvPr/>
          </p:nvSpPr>
          <p:spPr>
            <a:xfrm>
              <a:off x="706320" y="4535640"/>
              <a:ext cx="0" cy="14256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3" name="Straight Connector 47"/>
            <p:cNvSpPr/>
            <p:nvPr/>
          </p:nvSpPr>
          <p:spPr>
            <a:xfrm>
              <a:off x="706320" y="4710240"/>
              <a:ext cx="0" cy="14256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4" name="Straight Connector 48"/>
            <p:cNvSpPr/>
            <p:nvPr/>
          </p:nvSpPr>
          <p:spPr>
            <a:xfrm>
              <a:off x="706320" y="4883400"/>
              <a:ext cx="0" cy="14436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5" name="Straight Connector 49"/>
            <p:cNvSpPr/>
            <p:nvPr/>
          </p:nvSpPr>
          <p:spPr>
            <a:xfrm>
              <a:off x="706320" y="1046160"/>
              <a:ext cx="0" cy="492120"/>
            </a:xfrm>
            <a:prstGeom prst="line">
              <a:avLst/>
            </a:prstGeom>
            <a:ln w="38160">
              <a:solidFill>
                <a:srgbClr val="cc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6" name="Straight Connector 51"/>
            <p:cNvSpPr/>
            <p:nvPr/>
          </p:nvSpPr>
          <p:spPr>
            <a:xfrm>
              <a:off x="706320" y="1917720"/>
              <a:ext cx="0" cy="666720"/>
            </a:xfrm>
            <a:prstGeom prst="line">
              <a:avLst/>
            </a:prstGeom>
            <a:ln w="38160">
              <a:solidFill>
                <a:srgbClr val="0099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7" name="Straight Connector 52"/>
            <p:cNvSpPr/>
            <p:nvPr/>
          </p:nvSpPr>
          <p:spPr>
            <a:xfrm>
              <a:off x="706320" y="1568520"/>
              <a:ext cx="0" cy="144360"/>
            </a:xfrm>
            <a:prstGeom prst="line">
              <a:avLst/>
            </a:prstGeom>
            <a:ln w="38160">
              <a:solidFill>
                <a:srgbClr val="e287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8" name="Straight Connector 53"/>
            <p:cNvSpPr/>
            <p:nvPr/>
          </p:nvSpPr>
          <p:spPr>
            <a:xfrm>
              <a:off x="706320" y="1743120"/>
              <a:ext cx="0" cy="144360"/>
            </a:xfrm>
            <a:prstGeom prst="line">
              <a:avLst/>
            </a:prstGeom>
            <a:ln w="38160">
              <a:solidFill>
                <a:srgbClr val="0000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30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7-05T16:33:49Z</dcterms:created>
  <dc:creator>Youngmin Lee</dc:creator>
  <dc:description/>
  <dc:language>en-US</dc:language>
  <cp:lastModifiedBy>Young-Min Lee</cp:lastModifiedBy>
  <dcterms:modified xsi:type="dcterms:W3CDTF">2014-01-29T22:43:40Z</dcterms:modified>
  <cp:revision>268</cp:revision>
  <dc:subject/>
  <dc:title>PowerPoint 프레젠테이션</dc:title>
</cp:coreProperties>
</file>